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6"/>
  </p:handoutMasterIdLst>
  <p:sldIdLst>
    <p:sldId id="269" r:id="rId2"/>
    <p:sldId id="266" r:id="rId3"/>
    <p:sldId id="267" r:id="rId4"/>
    <p:sldId id="271" r:id="rId5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135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189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9899" y="0"/>
            <a:ext cx="2946189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39B85C-BC4D-4A92-B840-BFEA6A385781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9429909"/>
            <a:ext cx="2946189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9899" y="9429909"/>
            <a:ext cx="2946189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5447B5-10DD-4ECD-A0CC-29BAD7CC1E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144681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1040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9009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4369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9289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628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4996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863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1880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2436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5207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262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D399F-6323-4D2B-B364-FF6E972ECE60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47CD13-2942-420C-AC3A-CB1D3E42DB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4655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1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platzhalter 5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250704" cy="4691063"/>
          </a:xfrm>
        </p:spPr>
        <p:txBody>
          <a:bodyPr>
            <a:normAutofit fontScale="85000" lnSpcReduction="20000"/>
          </a:bodyPr>
          <a:lstStyle/>
          <a:p>
            <a:pPr algn="just">
              <a:lnSpc>
                <a:spcPct val="150000"/>
              </a:lnSpc>
            </a:pP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Shear stress-induced platelet aggregation.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Human platelets were circulated through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a polymer-free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parallel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plate flow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chamber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system for 5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min with shear rates of 100 s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and 1500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r>
              <a:rPr lang="en-US" baseline="300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A static control was kept under similar conditions: After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exposure to different shear rates, platelet aggregation was measured by light transmitting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aggregometry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Representative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curves for shear stress-induced platelet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aggregation are shown 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Bars show mean platelet aggregation ± SD after shear stress exposure of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5 independent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experiments 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lang="en-US" b="1" dirty="0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Additionally, platelets were characterized regarding their surface expression of P-selectin via FACS analysis (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) and PRP was collected for ELISA measurement of soluble fibrinogen 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Bars show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mean ± SD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of 5 independent experiments with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*p&lt;0.05 and ***p&lt;0.01.</a:t>
            </a:r>
            <a:endParaRPr lang="de-DE" dirty="0"/>
          </a:p>
        </p:txBody>
      </p:sp>
      <p:pic>
        <p:nvPicPr>
          <p:cNvPr id="3" name="Content Placeholder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2738" y="656460"/>
            <a:ext cx="5111750" cy="53648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073032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2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platzhalter 5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250704" cy="4691063"/>
          </a:xfrm>
        </p:spPr>
        <p:txBody>
          <a:bodyPr>
            <a:normAutofit fontScale="85000" lnSpcReduction="10000"/>
          </a:bodyPr>
          <a:lstStyle/>
          <a:p>
            <a:pPr algn="just">
              <a:lnSpc>
                <a:spcPct val="150000"/>
              </a:lnSpc>
            </a:pPr>
            <a:r>
              <a:rPr lang="en-US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Shear stress-induced monocyte activation.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Human peripheral blood mononuclear cells (PBMCs) were isolated from an in-line filter system for leukocyte filtration and exposed to the indicated polymer surfaces for 30 min using shear rates of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100 s</a:t>
            </a:r>
            <a:r>
              <a:rPr lang="en-US" baseline="300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and 1500 s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. Subsequently circulating PBMCs were characterized regarding their CD11b expression by FACS analysis. (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a)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Bars show mean proportion of CD11b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monocytes ± SD of 5 independent experiments after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exposure to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the indicated shear rates in a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polymer-free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control. (b)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Bars show mean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fluorescence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intensity (MFI) of CD11b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monocytes ± SD of 5 independent experiments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after exposure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to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the indicated shear rates in a polymer-free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control. Significances are given as **p &lt; 0.01 and ***p&lt;0.001.</a:t>
            </a:r>
            <a:endParaRPr lang="de-DE" dirty="0"/>
          </a:p>
        </p:txBody>
      </p:sp>
      <p:pic>
        <p:nvPicPr>
          <p:cNvPr id="4099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2463" y="273050"/>
            <a:ext cx="3816924" cy="5853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86600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3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platzhalter 5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250704" cy="4691063"/>
          </a:xfrm>
        </p:spPr>
        <p:txBody>
          <a:bodyPr>
            <a:normAutofit fontScale="85000" lnSpcReduction="20000"/>
          </a:bodyPr>
          <a:lstStyle/>
          <a:p>
            <a:pPr algn="just">
              <a:lnSpc>
                <a:spcPct val="150000"/>
              </a:lnSpc>
            </a:pP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Formation </a:t>
            </a:r>
            <a:r>
              <a:rPr lang="de-DE" b="1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of</a:t>
            </a: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de-DE" b="1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monocyte-bound</a:t>
            </a: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de-DE" b="1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platelet</a:t>
            </a: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 (MBPs) </a:t>
            </a:r>
            <a:r>
              <a:rPr lang="de-DE" b="1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under</a:t>
            </a: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de-DE" b="1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flow</a:t>
            </a: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de-DE" b="1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conditions</a:t>
            </a:r>
            <a:r>
              <a:rPr lang="de-DE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lang="de-DE" dirty="0">
                <a:solidFill>
                  <a:srgbClr val="000000"/>
                </a:solidFill>
                <a:latin typeface="Times New Roman"/>
                <a:ea typeface="Times New Roman"/>
              </a:rPr>
              <a:t>Human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platelets and leukocytes were isolated separately and </a:t>
            </a:r>
            <a:r>
              <a:rPr lang="en-US" dirty="0" err="1">
                <a:solidFill>
                  <a:srgbClr val="000000"/>
                </a:solidFill>
                <a:latin typeface="Times New Roman"/>
                <a:ea typeface="Times New Roman"/>
              </a:rPr>
              <a:t>resuspended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in platelet poor plasma (PPP) at a physiological concentration of 3x10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platelets/ml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and 5x10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leukocytes/ml.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Blood cell suspensions were circulated through a parallel plate flow chamber system, containing the different polymers, for 30 min with shear rates of 100 s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1500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r>
              <a:rPr lang="en-US" baseline="30000" dirty="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. After flow exposure,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MBPs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were identified within the monocyte population by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CD14/CD62P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expression. (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a)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Bars show the mean proportion of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CD14</a:t>
            </a:r>
            <a:r>
              <a:rPr lang="en-US" baseline="300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/CD62P</a:t>
            </a:r>
            <a:r>
              <a:rPr lang="en-US" baseline="300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 MBPs ± SD under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static and flow conditions of 5 independent experiments with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p&lt;0.01.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(b)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Bars show mean fluorescence intensity (MFI) of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CD14+/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CD62P+ 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MBPs ± SD under </a:t>
            </a:r>
            <a:r>
              <a:rPr lang="en-US" dirty="0">
                <a:solidFill>
                  <a:srgbClr val="000000"/>
                </a:solidFill>
                <a:latin typeface="Times New Roman"/>
                <a:ea typeface="Times New Roman"/>
              </a:rPr>
              <a:t>static and flow conditions of 5 independent experiments with *</a:t>
            </a:r>
            <a:r>
              <a:rPr lang="en-US" dirty="0" smtClean="0">
                <a:solidFill>
                  <a:srgbClr val="000000"/>
                </a:solidFill>
                <a:latin typeface="Times New Roman"/>
                <a:ea typeface="Times New Roman"/>
              </a:rPr>
              <a:t>p&lt;0.05.</a:t>
            </a:r>
            <a:endParaRPr lang="de-DE" dirty="0">
              <a:solidFill>
                <a:srgbClr val="000000"/>
              </a:solidFill>
              <a:latin typeface="Times New Roman"/>
              <a:ea typeface="Times New Roman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8608" y="273050"/>
            <a:ext cx="3524634" cy="5853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034545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de-DE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de-DE" dirty="0"/>
          </a:p>
        </p:txBody>
      </p:sp>
      <p:graphicFrame>
        <p:nvGraphicFramePr>
          <p:cNvPr id="5" name="Inhaltsplatzhalt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09567350"/>
              </p:ext>
            </p:extLst>
          </p:nvPr>
        </p:nvGraphicFramePr>
        <p:xfrm>
          <a:off x="539552" y="2276872"/>
          <a:ext cx="7488833" cy="26771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4962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81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81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81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813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85420">
                <a:tc rowSpan="2"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                        </a:t>
                      </a:r>
                      <a:r>
                        <a:rPr lang="de-DE" sz="1400" dirty="0" err="1" smtClean="0"/>
                        <a:t>shear</a:t>
                      </a:r>
                      <a:r>
                        <a:rPr lang="de-DE" sz="1400" dirty="0" smtClean="0"/>
                        <a:t> rate</a:t>
                      </a:r>
                    </a:p>
                    <a:p>
                      <a:pPr algn="l"/>
                      <a:r>
                        <a:rPr lang="de-DE" sz="1400" dirty="0" smtClean="0"/>
                        <a:t>polymer</a:t>
                      </a:r>
                      <a:endParaRPr lang="de-DE" sz="1400" dirty="0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dirty="0" smtClean="0"/>
                        <a:t>100 s</a:t>
                      </a:r>
                      <a:r>
                        <a:rPr lang="de-DE" sz="1400" b="1" baseline="30000" dirty="0" smtClean="0"/>
                        <a:t>-1</a:t>
                      </a:r>
                      <a:endParaRPr lang="de-DE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dirty="0" smtClean="0"/>
                        <a:t>1500 s</a:t>
                      </a:r>
                      <a:r>
                        <a:rPr lang="de-DE" sz="1400" b="1" baseline="30000" dirty="0" smtClean="0"/>
                        <a:t>-1</a:t>
                      </a:r>
                      <a:endParaRPr lang="de-DE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4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Fibrinogen [mg/dl]</a:t>
                      </a:r>
                      <a:r>
                        <a:rPr lang="de-DE" sz="1400" b="1" dirty="0" smtClean="0"/>
                        <a:t> </a:t>
                      </a:r>
                      <a:endParaRPr lang="de-DE" sz="1400" b="1" baseline="30000" dirty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de-DE" sz="14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-</a:t>
                      </a:r>
                      <a:r>
                        <a:rPr lang="de-DE" sz="1400" b="1" kern="12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value</a:t>
                      </a:r>
                      <a:endParaRPr lang="de-DE" sz="14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4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Fibrinogen [mg/dl]</a:t>
                      </a:r>
                      <a:r>
                        <a:rPr lang="de-DE" sz="1400" b="1" dirty="0" smtClean="0"/>
                        <a:t> </a:t>
                      </a:r>
                      <a:endParaRPr lang="de-DE" sz="1400" b="1" dirty="0"/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de-DE" sz="14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-</a:t>
                      </a:r>
                      <a:r>
                        <a:rPr lang="de-DE" sz="1400" b="1" kern="12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value</a:t>
                      </a:r>
                      <a:endParaRPr lang="de-DE" sz="14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P(4HB)</a:t>
                      </a:r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647.7±44.8</a:t>
                      </a:r>
                      <a:endParaRPr lang="de-DE" sz="1400" dirty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&lt; 0.0001 </a:t>
                      </a:r>
                      <a:endParaRPr lang="de-DE" sz="1400" dirty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235.3±24.0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0.981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PCL</a:t>
                      </a:r>
                      <a:endParaRPr lang="de-DE" sz="1400" dirty="0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174.9±26.1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0.559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307.4±67.3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0.824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PLLA</a:t>
                      </a:r>
                      <a:endParaRPr lang="de-DE" sz="1400" dirty="0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228.1±19.3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400" dirty="0" smtClean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261.6±49.5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400" dirty="0" smtClean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PLLA/P(4HB)</a:t>
                      </a:r>
                      <a:endParaRPr lang="de-DE" sz="1400" dirty="0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579.5±150.8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&lt; 0.0001 </a:t>
                      </a:r>
                      <a:endParaRPr lang="de-DE" sz="1400" dirty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321.2±61.3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0.612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de-DE" sz="1400" dirty="0" smtClean="0"/>
                        <a:t>PLLA/PCL</a:t>
                      </a:r>
                      <a:endParaRPr lang="de-DE" sz="1400" dirty="0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265.7±62.1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0.858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420.4±114.4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dirty="0" smtClean="0"/>
                        <a:t>0.026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7715200" cy="4691063"/>
          </a:xfrm>
        </p:spPr>
        <p:txBody>
          <a:bodyPr>
            <a:normAutofit/>
          </a:bodyPr>
          <a:lstStyle/>
          <a:p>
            <a:pPr algn="just">
              <a:lnSpc>
                <a:spcPct val="150000"/>
              </a:lnSpc>
            </a:pPr>
            <a:r>
              <a:rPr lang="en-GB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Plasma fibrinogen concentration after shear stress exposure in presence of the indicated polymers. </a:t>
            </a:r>
            <a:r>
              <a:rPr lang="en-GB" dirty="0" smtClean="0">
                <a:solidFill>
                  <a:srgbClr val="000000"/>
                </a:solidFill>
                <a:latin typeface="Times New Roman"/>
                <a:ea typeface="Times New Roman"/>
              </a:rPr>
              <a:t>Statistical significances compared to PLLA were assessed by </a:t>
            </a:r>
            <a:r>
              <a:rPr lang="en-GB" smtClean="0">
                <a:solidFill>
                  <a:srgbClr val="000000"/>
                </a:solidFill>
                <a:latin typeface="Times New Roman"/>
                <a:ea typeface="Times New Roman"/>
              </a:rPr>
              <a:t>a two way-ANOVA</a:t>
            </a:r>
            <a:r>
              <a:rPr lang="en-GB" dirty="0" smtClean="0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lang="en-GB" dirty="0">
              <a:solidFill>
                <a:srgbClr val="000000"/>
              </a:solidFill>
              <a:latin typeface="Times New Roman"/>
              <a:ea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16936380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5</Words>
  <Application>Microsoft Office PowerPoint</Application>
  <PresentationFormat>On-screen Show (4:3)</PresentationFormat>
  <Paragraphs>3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Larissa</vt:lpstr>
      <vt:lpstr>Figure S1</vt:lpstr>
      <vt:lpstr>Figure S2</vt:lpstr>
      <vt:lpstr>Figure S3</vt:lpstr>
      <vt:lpstr>Table S1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Anne Strohbach</dc:creator>
  <cp:lastModifiedBy>MDPI</cp:lastModifiedBy>
  <cp:revision>179</cp:revision>
  <cp:lastPrinted>2021-04-07T10:59:07Z</cp:lastPrinted>
  <dcterms:created xsi:type="dcterms:W3CDTF">2020-06-22T07:38:38Z</dcterms:created>
  <dcterms:modified xsi:type="dcterms:W3CDTF">2021-06-13T12:00:10Z</dcterms:modified>
</cp:coreProperties>
</file>